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40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9E5382-EB48-87CB-2D20-F28EACB67E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2820B9-5504-0B3D-1C63-ADC958DF13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3925B5-D28C-4161-72D0-0672E94E0C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78871F-BBCE-D85F-1F09-42202BD4F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9CBE87-848A-D4FE-7D4B-1486FDF73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331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1D5323-92CE-C9F8-3B5F-376536D5CC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08B083-3A92-1512-B8A0-F4FC281403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94B4A2-C203-7C69-A28E-5433CE3DA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E3D34D-5EE9-0E33-5771-2A80328B6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9001AB-534B-AE7E-9EEE-7C0AED0365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0294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686F18-DBD1-1A53-5064-7296D2DEE6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3C3555-1C5D-8461-AE3E-7BB637376C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6D903F-A52F-80F7-816A-0F52563C11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7AE52D-60EF-0364-8F1F-BE2066C47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93F2B9-FB82-C3BF-F043-F0D3C35B6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6699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8D20D1-CA1D-2177-119D-CC101AA19C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F0A76C-6A19-AF43-36AF-B84F8A6261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3AEA3E-E015-ADCE-AC3E-16A7DDADD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99B5FD-B528-33BA-791C-902B9EA0D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E9ED5C-7564-BA56-13D3-5B5B8A057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7013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6F21F-914F-196F-7C21-3FE045D1DE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3C1EE4-5F1E-E7EF-0674-1F4C9EFBAA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B7CE7C-0847-3FFD-CF94-FB916AF28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98269-D611-0E75-CABE-7C4B7F163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CB5455-A0AF-294E-FD96-AC8F61206B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427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B08194-A6E6-41E6-3AD8-5F198C9832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ECAD93-AA7E-6C9D-C1E1-43E670FB68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E461CB-A607-BA87-B196-F47E0AEFF8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0B0F1D-3C41-8A15-DFF2-47BC4B659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96653D-829C-1EAD-4FDE-ACF9CCA39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DA3E9B-4149-6812-567A-7137AC6E9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8723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EA1E99-302D-DAA3-6A4F-3C647C404D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8E96C0-F64A-44CD-E19A-1366C1A10F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9B7921-6ABB-25ED-78D6-0B566BD94D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2A65324-8022-72C7-5248-B46E40FB96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11E531-A5D5-1A44-5773-50225306BB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6706F65-791E-8B24-3508-99DCEC1AB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E590C85-3D3F-9402-4369-C7FCE8A0F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078E605-3D71-33FB-BCE1-2D1E43BE3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0777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896475-3C62-1364-AEB9-DCFA777D5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7459C74-194C-E474-4FE5-839C99E58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399BF3F-234B-D3A5-6723-51BB192F7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A2003F-630D-7E8B-7D98-C11B69713D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2148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12BBB7-4CD8-FA89-7788-057BA68DC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B5392-B356-2B9B-8813-A827538429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5CEB28-49A3-1A2A-C837-25FBA3376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2336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04DC07-290D-C381-03E1-B65EA0FC62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493A44-74CA-CAEE-9DE8-8D4F24B58E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8BEC39-F339-59F2-8CBF-4524371B5D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627C97-8D0B-FC04-9E73-9431D7DEC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2D9B91-58E8-6659-C3D6-B32F17008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CEC3DB-667F-77F7-BF11-ABA967829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9494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B51BA8-C1A2-3327-690A-65F34768A0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7D0E51F-5BE2-1D51-7349-4DD23080C1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FF7D6C-375B-873D-96AD-3A5AE96E52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FAA39B-D8E2-EEFE-F679-B7A359464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23E93F-6F33-D4D7-3FCB-79E8BC605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AE03DF-5120-5955-C4BF-582495546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8867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A037DEE-D14C-B79D-A777-76A3B35404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0D0E8B-AB07-80F4-1F45-040B19D549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5D7096-E6A0-1B4F-6A2E-84235E1C14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50E77C8-ADC9-45C7-8A39-D4C843858036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33E282-475B-1FBF-7F10-CB8801833D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FCE755-F39C-2A0D-EAAA-B489BDD23A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59F92A-3526-496B-8AD2-126DE7FADB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3959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55B7F874-E679-97CD-2E0A-997B3B0069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568" y="0"/>
            <a:ext cx="9604246" cy="630726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4ED173D-91ED-CD7F-5042-76EC8DEF0624}"/>
              </a:ext>
            </a:extLst>
          </p:cNvPr>
          <p:cNvSpPr txBox="1"/>
          <p:nvPr/>
        </p:nvSpPr>
        <p:spPr>
          <a:xfrm>
            <a:off x="1327639" y="6312881"/>
            <a:ext cx="93813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i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2. </a:t>
            </a:r>
            <a:r>
              <a:rPr lang="es-ES" sz="1200" i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isualization with IGV of the sequencing reads (.bam) of the four samples in which WGS was performed. Each window shows a section of the TTR gene exon 2, where the V30M and G6S variants are located. Referenced to GRCh38.</a:t>
            </a:r>
            <a:endParaRPr lang="en-GB" sz="1200" i="1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03061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4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c Ventayol Guirado</dc:creator>
  <cp:lastModifiedBy>Marc Ventayol Guirado</cp:lastModifiedBy>
  <cp:revision>2</cp:revision>
  <dcterms:created xsi:type="dcterms:W3CDTF">2025-05-28T09:01:55Z</dcterms:created>
  <dcterms:modified xsi:type="dcterms:W3CDTF">2025-05-28T09:10:21Z</dcterms:modified>
</cp:coreProperties>
</file>